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45388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D1289-8C81-46D2-A125-4C05CE4765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7640" y="853560"/>
            <a:ext cx="678780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7640" y="2114280"/>
            <a:ext cx="678780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72483-69A1-4E5B-B81F-192777EBC8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7640" y="85356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55960" y="85356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7640" y="211428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55960" y="211428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F1E43-3C22-4D5A-949A-813E5FA66D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7640" y="853560"/>
            <a:ext cx="21855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3000" y="853560"/>
            <a:ext cx="21855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68000" y="853560"/>
            <a:ext cx="21855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7640" y="2114280"/>
            <a:ext cx="21855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3000" y="2114280"/>
            <a:ext cx="21855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68000" y="2114280"/>
            <a:ext cx="21855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07BC9-EB5E-4756-BCBE-2319DEE4A8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7640" y="853560"/>
            <a:ext cx="678780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219A4-6E43-47B8-AEA4-97A93A92DC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7640" y="853560"/>
            <a:ext cx="678780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819B4-2189-47A5-A951-0DF19A2E23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7640" y="853560"/>
            <a:ext cx="3312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55960" y="853560"/>
            <a:ext cx="3312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439BB-5A64-4ECB-B097-8828D5084F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052FE-6987-4413-9809-5F76A85C89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7640" y="145800"/>
            <a:ext cx="678780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6A7A1B-2426-41B2-BBBA-21A2705FE1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7640" y="85356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55960" y="853560"/>
            <a:ext cx="3312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7640" y="211428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15E80-9D73-4ACC-8FD3-D72EF7F333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7640" y="853560"/>
            <a:ext cx="3312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55960" y="85356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55960" y="211428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14FD2-010C-4169-9628-1AF6709951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7640" y="85356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55960" y="853560"/>
            <a:ext cx="3312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7640" y="2114280"/>
            <a:ext cx="678780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9816D-D31B-4690-B822-BC6E2429DA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7640" y="145800"/>
            <a:ext cx="678780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7640" y="853560"/>
            <a:ext cx="678780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 fontScale="85000"/>
          </a:bodyPr>
          <a:p>
            <a:pPr marL="203760" indent="-2037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442440" indent="-16956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2" marL="680040" indent="-13644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3" marL="952560" indent="-13608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4" marL="1224000" indent="-13644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5" marL="1224000" indent="-13644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6" marL="1224000" indent="-13644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3330360"/>
            <a:ext cx="1758600" cy="25380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Autofit/>
          </a:bodyPr>
          <a:lstStyle>
            <a:lvl1pPr indent="0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77600" y="3330360"/>
            <a:ext cx="2387880" cy="25380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Autofit/>
          </a:bodyPr>
          <a:lstStyle>
            <a:lvl1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06840" y="3330360"/>
            <a:ext cx="1758600" cy="25380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Autofit/>
          </a:bodyPr>
          <a:lstStyle>
            <a:lvl1pPr indent="0" algn="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639720"/>
                <a:tab algn="l" pos="1279440"/>
                <a:tab algn="l" pos="1919160"/>
                <a:tab algn="l" pos="2558880"/>
                <a:tab algn="l" pos="3198960"/>
                <a:tab algn="l" pos="3838680"/>
                <a:tab algn="l" pos="4478400"/>
                <a:tab algn="l" pos="5118120"/>
                <a:tab algn="l" pos="5757840"/>
                <a:tab algn="l" pos="6397560"/>
                <a:tab algn="l" pos="7037280"/>
                <a:tab algn="l" pos="7677000"/>
                <a:tab algn="l" pos="8317080"/>
                <a:tab algn="l" pos="8956800"/>
                <a:tab algn="l" pos="9596520"/>
                <a:tab algn="l" pos="10236240"/>
                <a:tab algn="l" pos="10875960"/>
              </a:tabLst>
            </a:pPr>
            <a:fld id="{08ED1059-E9B3-466D-B866-31ED2D49C1FB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240" y="0"/>
            <a:ext cx="7538040" cy="3654360"/>
            <a:chOff x="3240" y="0"/>
            <a:chExt cx="7538040" cy="3654360"/>
          </a:xfrm>
        </p:grpSpPr>
        <p:grpSp>
          <p:nvGrpSpPr>
            <p:cNvPr id="42" name=""/>
            <p:cNvGrpSpPr/>
            <p:nvPr/>
          </p:nvGrpSpPr>
          <p:grpSpPr>
            <a:xfrm>
              <a:off x="545400" y="3177360"/>
              <a:ext cx="3061080" cy="155520"/>
              <a:chOff x="545400" y="3177360"/>
              <a:chExt cx="3061080" cy="155520"/>
            </a:xfrm>
          </p:grpSpPr>
          <p:sp>
            <p:nvSpPr>
              <p:cNvPr id="43" name=""/>
              <p:cNvSpPr/>
              <p:nvPr/>
            </p:nvSpPr>
            <p:spPr>
              <a:xfrm>
                <a:off x="3255120" y="318024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2592720" y="318024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908720" y="318024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6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224360" y="318024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545400" y="317736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"/>
            <p:cNvGrpSpPr/>
            <p:nvPr/>
          </p:nvGrpSpPr>
          <p:grpSpPr>
            <a:xfrm>
              <a:off x="623520" y="3120480"/>
              <a:ext cx="2728440" cy="25560"/>
              <a:chOff x="623520" y="3120480"/>
              <a:chExt cx="2728440" cy="25560"/>
            </a:xfrm>
          </p:grpSpPr>
          <p:sp>
            <p:nvSpPr>
              <p:cNvPr id="49" name=""/>
              <p:cNvSpPr/>
              <p:nvPr/>
            </p:nvSpPr>
            <p:spPr>
              <a:xfrm flipV="1">
                <a:off x="623520" y="312048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V="1">
                <a:off x="962280" y="312084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V="1">
                <a:off x="1301400" y="312048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1648440" y="312084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 flipV="1">
                <a:off x="1987200" y="312048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V="1">
                <a:off x="2326320" y="312084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V="1">
                <a:off x="2673360" y="312048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V="1">
                <a:off x="3012480" y="312084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V="1">
                <a:off x="3351240" y="312048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623520" y="3120840"/>
                <a:ext cx="2727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9" name=""/>
            <p:cNvGrpSpPr/>
            <p:nvPr/>
          </p:nvGrpSpPr>
          <p:grpSpPr>
            <a:xfrm>
              <a:off x="310320" y="306000"/>
              <a:ext cx="176040" cy="2885760"/>
              <a:chOff x="310320" y="306000"/>
              <a:chExt cx="176040" cy="2885760"/>
            </a:xfrm>
          </p:grpSpPr>
          <p:sp>
            <p:nvSpPr>
              <p:cNvPr id="60" name=""/>
              <p:cNvSpPr/>
              <p:nvPr/>
            </p:nvSpPr>
            <p:spPr>
              <a:xfrm>
                <a:off x="310320" y="30391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10320" y="26438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310320" y="22561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10320" y="186696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310320" y="14810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310320" y="10872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310320" y="6994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310320" y="3060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"/>
            <p:cNvGrpSpPr/>
            <p:nvPr/>
          </p:nvGrpSpPr>
          <p:grpSpPr>
            <a:xfrm>
              <a:off x="592560" y="388800"/>
              <a:ext cx="31680" cy="2732760"/>
              <a:chOff x="592560" y="388800"/>
              <a:chExt cx="31680" cy="2732760"/>
            </a:xfrm>
          </p:grpSpPr>
          <p:sp>
            <p:nvSpPr>
              <p:cNvPr id="69" name=""/>
              <p:cNvSpPr/>
              <p:nvPr/>
            </p:nvSpPr>
            <p:spPr>
              <a:xfrm flipH="1">
                <a:off x="592560" y="3121200"/>
                <a:ext cx="3096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flipH="1">
                <a:off x="607680" y="2924640"/>
                <a:ext cx="154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H="1">
                <a:off x="592560" y="2728080"/>
                <a:ext cx="309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H="1">
                <a:off x="607680" y="2538000"/>
                <a:ext cx="154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H="1">
                <a:off x="592560" y="2341440"/>
                <a:ext cx="3096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flipH="1">
                <a:off x="607680" y="2144880"/>
                <a:ext cx="154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H="1">
                <a:off x="592560" y="1948320"/>
                <a:ext cx="3096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H="1">
                <a:off x="607680" y="1757880"/>
                <a:ext cx="154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flipH="1">
                <a:off x="592560" y="1561320"/>
                <a:ext cx="309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H="1">
                <a:off x="607680" y="1365120"/>
                <a:ext cx="154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H="1">
                <a:off x="592560" y="1168560"/>
                <a:ext cx="3096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H="1">
                <a:off x="607680" y="972000"/>
                <a:ext cx="154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H="1">
                <a:off x="592560" y="781560"/>
                <a:ext cx="309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H="1">
                <a:off x="607680" y="585000"/>
                <a:ext cx="154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flipH="1">
                <a:off x="592560" y="388800"/>
                <a:ext cx="309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623520" y="388800"/>
                <a:ext cx="720" cy="2732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5" name=""/>
            <p:cNvGrpSpPr/>
            <p:nvPr/>
          </p:nvGrpSpPr>
          <p:grpSpPr>
            <a:xfrm>
              <a:off x="631440" y="2077920"/>
              <a:ext cx="38880" cy="30600"/>
              <a:chOff x="631440" y="2077920"/>
              <a:chExt cx="38880" cy="30600"/>
            </a:xfrm>
          </p:grpSpPr>
          <p:sp>
            <p:nvSpPr>
              <p:cNvPr id="86" name=""/>
              <p:cNvSpPr/>
              <p:nvPr/>
            </p:nvSpPr>
            <p:spPr>
              <a:xfrm>
                <a:off x="631440" y="207792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646920" y="20901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8" name=""/>
            <p:cNvGrpSpPr/>
            <p:nvPr/>
          </p:nvGrpSpPr>
          <p:grpSpPr>
            <a:xfrm>
              <a:off x="836280" y="904680"/>
              <a:ext cx="40320" cy="30240"/>
              <a:chOff x="836280" y="904680"/>
              <a:chExt cx="40320" cy="30240"/>
            </a:xfrm>
          </p:grpSpPr>
          <p:sp>
            <p:nvSpPr>
              <p:cNvPr id="89" name=""/>
              <p:cNvSpPr/>
              <p:nvPr/>
            </p:nvSpPr>
            <p:spPr>
              <a:xfrm>
                <a:off x="836280" y="904680"/>
                <a:ext cx="4032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852480" y="9165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1" name=""/>
            <p:cNvGrpSpPr/>
            <p:nvPr/>
          </p:nvGrpSpPr>
          <p:grpSpPr>
            <a:xfrm>
              <a:off x="844200" y="745920"/>
              <a:ext cx="38520" cy="30240"/>
              <a:chOff x="844200" y="745920"/>
              <a:chExt cx="38520" cy="30240"/>
            </a:xfrm>
          </p:grpSpPr>
          <p:sp>
            <p:nvSpPr>
              <p:cNvPr id="92" name=""/>
              <p:cNvSpPr/>
              <p:nvPr/>
            </p:nvSpPr>
            <p:spPr>
              <a:xfrm>
                <a:off x="844200" y="745920"/>
                <a:ext cx="3852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859320" y="75780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4" name=""/>
            <p:cNvGrpSpPr/>
            <p:nvPr/>
          </p:nvGrpSpPr>
          <p:grpSpPr>
            <a:xfrm>
              <a:off x="907560" y="1487880"/>
              <a:ext cx="38520" cy="30600"/>
              <a:chOff x="907560" y="1487880"/>
              <a:chExt cx="38520" cy="30600"/>
            </a:xfrm>
          </p:grpSpPr>
          <p:sp>
            <p:nvSpPr>
              <p:cNvPr id="95" name=""/>
              <p:cNvSpPr/>
              <p:nvPr/>
            </p:nvSpPr>
            <p:spPr>
              <a:xfrm>
                <a:off x="907560" y="148788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922680" y="150012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"/>
            <p:cNvGrpSpPr/>
            <p:nvPr/>
          </p:nvGrpSpPr>
          <p:grpSpPr>
            <a:xfrm>
              <a:off x="946080" y="2230560"/>
              <a:ext cx="40680" cy="30600"/>
              <a:chOff x="946080" y="2230560"/>
              <a:chExt cx="40680" cy="30600"/>
            </a:xfrm>
          </p:grpSpPr>
          <p:sp>
            <p:nvSpPr>
              <p:cNvPr id="98" name=""/>
              <p:cNvSpPr/>
              <p:nvPr/>
            </p:nvSpPr>
            <p:spPr>
              <a:xfrm>
                <a:off x="946080" y="2230560"/>
                <a:ext cx="406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962280" y="22428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0" name=""/>
            <p:cNvGrpSpPr/>
            <p:nvPr/>
          </p:nvGrpSpPr>
          <p:grpSpPr>
            <a:xfrm>
              <a:off x="954720" y="2893680"/>
              <a:ext cx="38520" cy="30600"/>
              <a:chOff x="954720" y="2893680"/>
              <a:chExt cx="38520" cy="30600"/>
            </a:xfrm>
          </p:grpSpPr>
          <p:sp>
            <p:nvSpPr>
              <p:cNvPr id="101" name=""/>
              <p:cNvSpPr/>
              <p:nvPr/>
            </p:nvSpPr>
            <p:spPr>
              <a:xfrm>
                <a:off x="954720" y="289368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969840" y="29059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3" name=""/>
            <p:cNvGrpSpPr/>
            <p:nvPr/>
          </p:nvGrpSpPr>
          <p:grpSpPr>
            <a:xfrm>
              <a:off x="962640" y="1917720"/>
              <a:ext cx="38520" cy="30600"/>
              <a:chOff x="962640" y="1917720"/>
              <a:chExt cx="38520" cy="30600"/>
            </a:xfrm>
          </p:grpSpPr>
          <p:sp>
            <p:nvSpPr>
              <p:cNvPr id="104" name=""/>
              <p:cNvSpPr/>
              <p:nvPr/>
            </p:nvSpPr>
            <p:spPr>
              <a:xfrm>
                <a:off x="962640" y="191772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977760" y="192996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6" name=""/>
            <p:cNvGrpSpPr/>
            <p:nvPr/>
          </p:nvGrpSpPr>
          <p:grpSpPr>
            <a:xfrm>
              <a:off x="1056600" y="1745640"/>
              <a:ext cx="40680" cy="30600"/>
              <a:chOff x="1056600" y="1745640"/>
              <a:chExt cx="40680" cy="30600"/>
            </a:xfrm>
          </p:grpSpPr>
          <p:sp>
            <p:nvSpPr>
              <p:cNvPr id="107" name=""/>
              <p:cNvSpPr/>
              <p:nvPr/>
            </p:nvSpPr>
            <p:spPr>
              <a:xfrm>
                <a:off x="1056600" y="1745640"/>
                <a:ext cx="406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1072800" y="17578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9" name=""/>
            <p:cNvGrpSpPr/>
            <p:nvPr/>
          </p:nvGrpSpPr>
          <p:grpSpPr>
            <a:xfrm>
              <a:off x="1097640" y="1954800"/>
              <a:ext cx="38520" cy="30600"/>
              <a:chOff x="1097640" y="1954800"/>
              <a:chExt cx="38520" cy="30600"/>
            </a:xfrm>
          </p:grpSpPr>
          <p:sp>
            <p:nvSpPr>
              <p:cNvPr id="110" name=""/>
              <p:cNvSpPr/>
              <p:nvPr/>
            </p:nvSpPr>
            <p:spPr>
              <a:xfrm>
                <a:off x="1097640" y="195480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1112760" y="196704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2" name=""/>
            <p:cNvGrpSpPr/>
            <p:nvPr/>
          </p:nvGrpSpPr>
          <p:grpSpPr>
            <a:xfrm>
              <a:off x="1103760" y="1648800"/>
              <a:ext cx="40320" cy="30600"/>
              <a:chOff x="1103760" y="1648800"/>
              <a:chExt cx="40320" cy="30600"/>
            </a:xfrm>
          </p:grpSpPr>
          <p:sp>
            <p:nvSpPr>
              <p:cNvPr id="113" name=""/>
              <p:cNvSpPr/>
              <p:nvPr/>
            </p:nvSpPr>
            <p:spPr>
              <a:xfrm>
                <a:off x="1103760" y="164880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1119600" y="166104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5" name=""/>
            <p:cNvGrpSpPr/>
            <p:nvPr/>
          </p:nvGrpSpPr>
          <p:grpSpPr>
            <a:xfrm>
              <a:off x="1136160" y="1954800"/>
              <a:ext cx="38880" cy="30600"/>
              <a:chOff x="1136160" y="1954800"/>
              <a:chExt cx="38880" cy="30600"/>
            </a:xfrm>
          </p:grpSpPr>
          <p:sp>
            <p:nvSpPr>
              <p:cNvPr id="116" name=""/>
              <p:cNvSpPr/>
              <p:nvPr/>
            </p:nvSpPr>
            <p:spPr>
              <a:xfrm>
                <a:off x="1136160" y="195480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1151640" y="196704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8" name=""/>
            <p:cNvGrpSpPr/>
            <p:nvPr/>
          </p:nvGrpSpPr>
          <p:grpSpPr>
            <a:xfrm>
              <a:off x="1152360" y="1954800"/>
              <a:ext cx="38880" cy="30600"/>
              <a:chOff x="1152360" y="1954800"/>
              <a:chExt cx="38880" cy="30600"/>
            </a:xfrm>
          </p:grpSpPr>
          <p:sp>
            <p:nvSpPr>
              <p:cNvPr id="119" name=""/>
              <p:cNvSpPr/>
              <p:nvPr/>
            </p:nvSpPr>
            <p:spPr>
              <a:xfrm>
                <a:off x="1152360" y="195480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1167840" y="196704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1" name=""/>
            <p:cNvGrpSpPr/>
            <p:nvPr/>
          </p:nvGrpSpPr>
          <p:grpSpPr>
            <a:xfrm>
              <a:off x="1167120" y="1586880"/>
              <a:ext cx="40320" cy="30600"/>
              <a:chOff x="1167120" y="1586880"/>
              <a:chExt cx="40320" cy="30600"/>
            </a:xfrm>
          </p:grpSpPr>
          <p:sp>
            <p:nvSpPr>
              <p:cNvPr id="122" name=""/>
              <p:cNvSpPr/>
              <p:nvPr/>
            </p:nvSpPr>
            <p:spPr>
              <a:xfrm>
                <a:off x="1167120" y="158688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1183320" y="15991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4" name=""/>
            <p:cNvGrpSpPr/>
            <p:nvPr/>
          </p:nvGrpSpPr>
          <p:grpSpPr>
            <a:xfrm>
              <a:off x="1238400" y="1745640"/>
              <a:ext cx="38880" cy="30600"/>
              <a:chOff x="1238400" y="1745640"/>
              <a:chExt cx="38880" cy="30600"/>
            </a:xfrm>
          </p:grpSpPr>
          <p:sp>
            <p:nvSpPr>
              <p:cNvPr id="125" name=""/>
              <p:cNvSpPr/>
              <p:nvPr/>
            </p:nvSpPr>
            <p:spPr>
              <a:xfrm>
                <a:off x="1238400" y="174564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1253880" y="17578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7" name=""/>
            <p:cNvGrpSpPr/>
            <p:nvPr/>
          </p:nvGrpSpPr>
          <p:grpSpPr>
            <a:xfrm>
              <a:off x="1269360" y="1505880"/>
              <a:ext cx="40320" cy="30240"/>
              <a:chOff x="1269360" y="1505880"/>
              <a:chExt cx="40320" cy="30240"/>
            </a:xfrm>
          </p:grpSpPr>
          <p:sp>
            <p:nvSpPr>
              <p:cNvPr id="128" name=""/>
              <p:cNvSpPr/>
              <p:nvPr/>
            </p:nvSpPr>
            <p:spPr>
              <a:xfrm>
                <a:off x="1269360" y="1505880"/>
                <a:ext cx="4032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1285200" y="151812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0" name=""/>
            <p:cNvGrpSpPr/>
            <p:nvPr/>
          </p:nvGrpSpPr>
          <p:grpSpPr>
            <a:xfrm>
              <a:off x="1324800" y="1334160"/>
              <a:ext cx="40320" cy="30600"/>
              <a:chOff x="1324800" y="1334160"/>
              <a:chExt cx="40320" cy="30600"/>
            </a:xfrm>
          </p:grpSpPr>
          <p:sp>
            <p:nvSpPr>
              <p:cNvPr id="131" name=""/>
              <p:cNvSpPr/>
              <p:nvPr/>
            </p:nvSpPr>
            <p:spPr>
              <a:xfrm>
                <a:off x="1324800" y="133416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1340640" y="134640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"/>
            <p:cNvGrpSpPr/>
            <p:nvPr/>
          </p:nvGrpSpPr>
          <p:grpSpPr>
            <a:xfrm>
              <a:off x="1365120" y="1391040"/>
              <a:ext cx="38880" cy="28800"/>
              <a:chOff x="1365120" y="1391040"/>
              <a:chExt cx="38880" cy="28800"/>
            </a:xfrm>
          </p:grpSpPr>
          <p:sp>
            <p:nvSpPr>
              <p:cNvPr id="134" name=""/>
              <p:cNvSpPr/>
              <p:nvPr/>
            </p:nvSpPr>
            <p:spPr>
              <a:xfrm>
                <a:off x="1365120" y="1391040"/>
                <a:ext cx="38880" cy="288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1380600" y="14025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6" name=""/>
            <p:cNvGrpSpPr/>
            <p:nvPr/>
          </p:nvGrpSpPr>
          <p:grpSpPr>
            <a:xfrm>
              <a:off x="1404000" y="1531800"/>
              <a:ext cx="38880" cy="30600"/>
              <a:chOff x="1404000" y="1531800"/>
              <a:chExt cx="38880" cy="30600"/>
            </a:xfrm>
          </p:grpSpPr>
          <p:sp>
            <p:nvSpPr>
              <p:cNvPr id="137" name=""/>
              <p:cNvSpPr/>
              <p:nvPr/>
            </p:nvSpPr>
            <p:spPr>
              <a:xfrm>
                <a:off x="1404000" y="153180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1419480" y="154404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9" name=""/>
            <p:cNvGrpSpPr/>
            <p:nvPr/>
          </p:nvGrpSpPr>
          <p:grpSpPr>
            <a:xfrm>
              <a:off x="1482120" y="1450800"/>
              <a:ext cx="40320" cy="30600"/>
              <a:chOff x="1482120" y="1450800"/>
              <a:chExt cx="40320" cy="30600"/>
            </a:xfrm>
          </p:grpSpPr>
          <p:sp>
            <p:nvSpPr>
              <p:cNvPr id="140" name=""/>
              <p:cNvSpPr/>
              <p:nvPr/>
            </p:nvSpPr>
            <p:spPr>
              <a:xfrm>
                <a:off x="1482120" y="145080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498320" y="146304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2" name=""/>
            <p:cNvGrpSpPr/>
            <p:nvPr/>
          </p:nvGrpSpPr>
          <p:grpSpPr>
            <a:xfrm>
              <a:off x="1506600" y="1899720"/>
              <a:ext cx="38880" cy="30600"/>
              <a:chOff x="1506600" y="1899720"/>
              <a:chExt cx="38880" cy="30600"/>
            </a:xfrm>
          </p:grpSpPr>
          <p:sp>
            <p:nvSpPr>
              <p:cNvPr id="143" name=""/>
              <p:cNvSpPr/>
              <p:nvPr/>
            </p:nvSpPr>
            <p:spPr>
              <a:xfrm>
                <a:off x="1506600" y="189972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522080" y="19119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5" name=""/>
            <p:cNvGrpSpPr/>
            <p:nvPr/>
          </p:nvGrpSpPr>
          <p:grpSpPr>
            <a:xfrm>
              <a:off x="1608840" y="2169000"/>
              <a:ext cx="38520" cy="30600"/>
              <a:chOff x="1608840" y="2169000"/>
              <a:chExt cx="38520" cy="30600"/>
            </a:xfrm>
          </p:grpSpPr>
          <p:sp>
            <p:nvSpPr>
              <p:cNvPr id="146" name=""/>
              <p:cNvSpPr/>
              <p:nvPr/>
            </p:nvSpPr>
            <p:spPr>
              <a:xfrm>
                <a:off x="1608840" y="216900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1623960" y="218124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8" name=""/>
            <p:cNvGrpSpPr/>
            <p:nvPr/>
          </p:nvGrpSpPr>
          <p:grpSpPr>
            <a:xfrm>
              <a:off x="1672200" y="2428560"/>
              <a:ext cx="38520" cy="28800"/>
              <a:chOff x="1672200" y="2428560"/>
              <a:chExt cx="38520" cy="28800"/>
            </a:xfrm>
          </p:grpSpPr>
          <p:sp>
            <p:nvSpPr>
              <p:cNvPr id="149" name=""/>
              <p:cNvSpPr/>
              <p:nvPr/>
            </p:nvSpPr>
            <p:spPr>
              <a:xfrm>
                <a:off x="1672200" y="2428560"/>
                <a:ext cx="38520" cy="288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1687320" y="244008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1" name=""/>
            <p:cNvGrpSpPr/>
            <p:nvPr/>
          </p:nvGrpSpPr>
          <p:grpSpPr>
            <a:xfrm>
              <a:off x="1680120" y="1604880"/>
              <a:ext cx="38520" cy="30240"/>
              <a:chOff x="1680120" y="1604880"/>
              <a:chExt cx="38520" cy="30240"/>
            </a:xfrm>
          </p:grpSpPr>
          <p:sp>
            <p:nvSpPr>
              <p:cNvPr id="152" name=""/>
              <p:cNvSpPr/>
              <p:nvPr/>
            </p:nvSpPr>
            <p:spPr>
              <a:xfrm>
                <a:off x="1680120" y="1604880"/>
                <a:ext cx="3852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1695600" y="161676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4" name=""/>
            <p:cNvGrpSpPr/>
            <p:nvPr/>
          </p:nvGrpSpPr>
          <p:grpSpPr>
            <a:xfrm>
              <a:off x="1710720" y="1800720"/>
              <a:ext cx="40680" cy="30600"/>
              <a:chOff x="1710720" y="1800720"/>
              <a:chExt cx="40680" cy="30600"/>
            </a:xfrm>
          </p:grpSpPr>
          <p:sp>
            <p:nvSpPr>
              <p:cNvPr id="155" name=""/>
              <p:cNvSpPr/>
              <p:nvPr/>
            </p:nvSpPr>
            <p:spPr>
              <a:xfrm>
                <a:off x="1710720" y="1800720"/>
                <a:ext cx="406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1726920" y="181296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7" name=""/>
            <p:cNvGrpSpPr/>
            <p:nvPr/>
          </p:nvGrpSpPr>
          <p:grpSpPr>
            <a:xfrm>
              <a:off x="1798920" y="2525400"/>
              <a:ext cx="38520" cy="30600"/>
              <a:chOff x="1798920" y="2525400"/>
              <a:chExt cx="38520" cy="30600"/>
            </a:xfrm>
          </p:grpSpPr>
          <p:sp>
            <p:nvSpPr>
              <p:cNvPr id="158" name=""/>
              <p:cNvSpPr/>
              <p:nvPr/>
            </p:nvSpPr>
            <p:spPr>
              <a:xfrm>
                <a:off x="1798920" y="252540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1814400" y="253764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0" name=""/>
            <p:cNvGrpSpPr/>
            <p:nvPr/>
          </p:nvGrpSpPr>
          <p:grpSpPr>
            <a:xfrm>
              <a:off x="1798920" y="1432800"/>
              <a:ext cx="38520" cy="30600"/>
              <a:chOff x="1798920" y="1432800"/>
              <a:chExt cx="38520" cy="30600"/>
            </a:xfrm>
          </p:grpSpPr>
          <p:sp>
            <p:nvSpPr>
              <p:cNvPr id="161" name=""/>
              <p:cNvSpPr/>
              <p:nvPr/>
            </p:nvSpPr>
            <p:spPr>
              <a:xfrm>
                <a:off x="1798920" y="143280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1814400" y="14450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3" name=""/>
            <p:cNvGrpSpPr/>
            <p:nvPr/>
          </p:nvGrpSpPr>
          <p:grpSpPr>
            <a:xfrm>
              <a:off x="1837440" y="2501280"/>
              <a:ext cx="38880" cy="30600"/>
              <a:chOff x="1837440" y="2501280"/>
              <a:chExt cx="38880" cy="30600"/>
            </a:xfrm>
          </p:grpSpPr>
          <p:sp>
            <p:nvSpPr>
              <p:cNvPr id="164" name=""/>
              <p:cNvSpPr/>
              <p:nvPr/>
            </p:nvSpPr>
            <p:spPr>
              <a:xfrm>
                <a:off x="1837440" y="250128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852920" y="251352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6" name=""/>
            <p:cNvGrpSpPr/>
            <p:nvPr/>
          </p:nvGrpSpPr>
          <p:grpSpPr>
            <a:xfrm>
              <a:off x="1861920" y="1505880"/>
              <a:ext cx="38520" cy="30240"/>
              <a:chOff x="1861920" y="1505880"/>
              <a:chExt cx="38520" cy="30240"/>
            </a:xfrm>
          </p:grpSpPr>
          <p:sp>
            <p:nvSpPr>
              <p:cNvPr id="167" name=""/>
              <p:cNvSpPr/>
              <p:nvPr/>
            </p:nvSpPr>
            <p:spPr>
              <a:xfrm>
                <a:off x="1861920" y="1505880"/>
                <a:ext cx="3852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1877400" y="151812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9" name=""/>
            <p:cNvGrpSpPr/>
            <p:nvPr/>
          </p:nvGrpSpPr>
          <p:grpSpPr>
            <a:xfrm>
              <a:off x="2453040" y="2212560"/>
              <a:ext cx="38880" cy="30600"/>
              <a:chOff x="2453040" y="2212560"/>
              <a:chExt cx="38880" cy="30600"/>
            </a:xfrm>
          </p:grpSpPr>
          <p:sp>
            <p:nvSpPr>
              <p:cNvPr id="170" name=""/>
              <p:cNvSpPr/>
              <p:nvPr/>
            </p:nvSpPr>
            <p:spPr>
              <a:xfrm>
                <a:off x="2453040" y="221256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468520" y="22248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2" name=""/>
            <p:cNvGrpSpPr/>
            <p:nvPr/>
          </p:nvGrpSpPr>
          <p:grpSpPr>
            <a:xfrm>
              <a:off x="2681640" y="1549800"/>
              <a:ext cx="38880" cy="30600"/>
              <a:chOff x="2681640" y="1549800"/>
              <a:chExt cx="38880" cy="30600"/>
            </a:xfrm>
          </p:grpSpPr>
          <p:sp>
            <p:nvSpPr>
              <p:cNvPr id="173" name=""/>
              <p:cNvSpPr/>
              <p:nvPr/>
            </p:nvSpPr>
            <p:spPr>
              <a:xfrm>
                <a:off x="2681640" y="154980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2697120" y="15620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5" name=""/>
            <p:cNvGrpSpPr/>
            <p:nvPr/>
          </p:nvGrpSpPr>
          <p:grpSpPr>
            <a:xfrm>
              <a:off x="623520" y="1684440"/>
              <a:ext cx="2727000" cy="417960"/>
              <a:chOff x="623520" y="1684440"/>
              <a:chExt cx="2727000" cy="417960"/>
            </a:xfrm>
          </p:grpSpPr>
          <p:sp>
            <p:nvSpPr>
              <p:cNvPr id="176" name=""/>
              <p:cNvSpPr/>
              <p:nvPr/>
            </p:nvSpPr>
            <p:spPr>
              <a:xfrm>
                <a:off x="623520" y="1684440"/>
                <a:ext cx="2727000" cy="417960"/>
              </a:xfrm>
              <a:custGeom>
                <a:avLst/>
                <a:gdLst/>
                <a:ahLst/>
                <a:rect l="l" t="t" r="r" b="b"/>
                <a:pathLst>
                  <a:path w="2768" h="544">
                    <a:moveTo>
                      <a:pt x="0" y="0"/>
                    </a:moveTo>
                    <a:lnTo>
                      <a:pt x="2768" y="544"/>
                    </a:lnTo>
                    <a:lnTo>
                      <a:pt x="2768" y="544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623520" y="1684440"/>
                <a:ext cx="2727000" cy="417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8" name=""/>
            <p:cNvSpPr/>
            <p:nvPr/>
          </p:nvSpPr>
          <p:spPr>
            <a:xfrm>
              <a:off x="801720" y="336960"/>
              <a:ext cx="221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639720"/>
                  <a:tab algn="l" pos="1279440"/>
                  <a:tab algn="l" pos="1919160"/>
                  <a:tab algn="l" pos="2558880"/>
                  <a:tab algn="l" pos="3198960"/>
                  <a:tab algn="l" pos="3838680"/>
                  <a:tab algn="l" pos="4478400"/>
                  <a:tab algn="l" pos="5118120"/>
                  <a:tab algn="l" pos="5757840"/>
                  <a:tab algn="l" pos="6397560"/>
                  <a:tab algn="l" pos="7037280"/>
                  <a:tab algn="l" pos="7677000"/>
                  <a:tab algn="l" pos="8317080"/>
                  <a:tab algn="l" pos="8956800"/>
                  <a:tab algn="l" pos="9596520"/>
                  <a:tab algn="l" pos="10236240"/>
                  <a:tab algn="l" pos="1087596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Palatino"/>
                </a:rPr>
                <a:t>y = 0.99048 - 2.6781e-5x   R^2 = 0.0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1202400" y="20880"/>
              <a:ext cx="1389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39720"/>
                  <a:tab algn="l" pos="1279440"/>
                  <a:tab algn="l" pos="1919160"/>
                  <a:tab algn="l" pos="2558880"/>
                  <a:tab algn="l" pos="3198960"/>
                  <a:tab algn="l" pos="3838680"/>
                  <a:tab algn="l" pos="4478400"/>
                  <a:tab algn="l" pos="5118120"/>
                  <a:tab algn="l" pos="5757840"/>
                  <a:tab algn="l" pos="6397560"/>
                  <a:tab algn="l" pos="7037280"/>
                  <a:tab algn="l" pos="7677000"/>
                  <a:tab algn="l" pos="8317080"/>
                  <a:tab algn="l" pos="8956800"/>
                  <a:tab algn="l" pos="9596520"/>
                  <a:tab algn="l" pos="10236240"/>
                  <a:tab algn="l" pos="1087596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Palatino"/>
                </a:rPr>
                <a:t>a) Meal Fat Oxid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16200000">
              <a:off x="-645840" y="1645920"/>
              <a:ext cx="1451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639720"/>
                  <a:tab algn="l" pos="1279440"/>
                  <a:tab algn="l" pos="1919160"/>
                  <a:tab algn="l" pos="2558880"/>
                  <a:tab algn="l" pos="3198960"/>
                  <a:tab algn="l" pos="3838680"/>
                  <a:tab algn="l" pos="4478400"/>
                  <a:tab algn="l" pos="5118120"/>
                  <a:tab algn="l" pos="5757840"/>
                  <a:tab algn="l" pos="6397560"/>
                  <a:tab algn="l" pos="7037280"/>
                  <a:tab algn="l" pos="7677000"/>
                  <a:tab algn="l" pos="8317080"/>
                  <a:tab algn="l" pos="8956800"/>
                  <a:tab algn="l" pos="9596520"/>
                  <a:tab algn="l" pos="10236240"/>
                  <a:tab algn="l" pos="1087596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al fat oxidation (g/6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323440" y="3501720"/>
              <a:ext cx="2490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39720"/>
                  <a:tab algn="l" pos="1279440"/>
                  <a:tab algn="l" pos="1919160"/>
                  <a:tab algn="l" pos="2558880"/>
                  <a:tab algn="l" pos="3198960"/>
                  <a:tab algn="l" pos="3838680"/>
                  <a:tab algn="l" pos="4478400"/>
                  <a:tab algn="l" pos="5118120"/>
                  <a:tab algn="l" pos="5757840"/>
                  <a:tab algn="l" pos="6397560"/>
                  <a:tab algn="l" pos="7037280"/>
                  <a:tab algn="l" pos="7677000"/>
                  <a:tab algn="l" pos="8317080"/>
                  <a:tab algn="l" pos="8956800"/>
                  <a:tab algn="l" pos="9596520"/>
                  <a:tab algn="l" pos="10236240"/>
                  <a:tab algn="l" pos="1087596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rea under insulin curve (ng/mL.360 min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5125680" y="0"/>
              <a:ext cx="1415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39720"/>
                  <a:tab algn="l" pos="1279440"/>
                  <a:tab algn="l" pos="1919160"/>
                  <a:tab algn="l" pos="2558880"/>
                  <a:tab algn="l" pos="3198960"/>
                  <a:tab algn="l" pos="3838680"/>
                  <a:tab algn="l" pos="4478400"/>
                  <a:tab algn="l" pos="5118120"/>
                  <a:tab algn="l" pos="5757840"/>
                  <a:tab algn="l" pos="6397560"/>
                  <a:tab algn="l" pos="7037280"/>
                  <a:tab algn="l" pos="7677000"/>
                  <a:tab algn="l" pos="8317080"/>
                  <a:tab algn="l" pos="8956800"/>
                  <a:tab algn="l" pos="9596520"/>
                  <a:tab algn="l" pos="10236240"/>
                  <a:tab algn="l" pos="1087596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Palatino"/>
                </a:rPr>
                <a:t>b) Total Fat Oxid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3" name=""/>
            <p:cNvGrpSpPr/>
            <p:nvPr/>
          </p:nvGrpSpPr>
          <p:grpSpPr>
            <a:xfrm>
              <a:off x="4477680" y="3165840"/>
              <a:ext cx="3063600" cy="152640"/>
              <a:chOff x="4477680" y="3165840"/>
              <a:chExt cx="3063600" cy="152640"/>
            </a:xfrm>
          </p:grpSpPr>
          <p:sp>
            <p:nvSpPr>
              <p:cNvPr id="184" name=""/>
              <p:cNvSpPr/>
              <p:nvPr/>
            </p:nvSpPr>
            <p:spPr>
              <a:xfrm>
                <a:off x="7189920" y="3165840"/>
                <a:ext cx="351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0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6528240" y="316584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5842440" y="316584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6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5156280" y="316584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4477680" y="316584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9" name=""/>
            <p:cNvGrpSpPr/>
            <p:nvPr/>
          </p:nvGrpSpPr>
          <p:grpSpPr>
            <a:xfrm>
              <a:off x="4558320" y="3110760"/>
              <a:ext cx="2731680" cy="25920"/>
              <a:chOff x="4558320" y="3110760"/>
              <a:chExt cx="2731680" cy="25920"/>
            </a:xfrm>
          </p:grpSpPr>
          <p:sp>
            <p:nvSpPr>
              <p:cNvPr id="190" name=""/>
              <p:cNvSpPr/>
              <p:nvPr/>
            </p:nvSpPr>
            <p:spPr>
              <a:xfrm flipV="1">
                <a:off x="4558320" y="3110760"/>
                <a:ext cx="720" cy="25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 flipV="1">
                <a:off x="4897440" y="311076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V="1">
                <a:off x="5236920" y="3110760"/>
                <a:ext cx="720" cy="25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 flipV="1">
                <a:off x="5584320" y="311076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V="1">
                <a:off x="5923800" y="3110760"/>
                <a:ext cx="720" cy="25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 flipV="1">
                <a:off x="6263280" y="311076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flipV="1">
                <a:off x="6610680" y="3110760"/>
                <a:ext cx="720" cy="25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 flipV="1">
                <a:off x="6949800" y="311076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flipV="1">
                <a:off x="7289280" y="3110760"/>
                <a:ext cx="720" cy="25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4558320" y="3110760"/>
                <a:ext cx="27309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0" name=""/>
            <p:cNvGrpSpPr/>
            <p:nvPr/>
          </p:nvGrpSpPr>
          <p:grpSpPr>
            <a:xfrm>
              <a:off x="4281840" y="319320"/>
              <a:ext cx="140760" cy="2876400"/>
              <a:chOff x="4281840" y="319320"/>
              <a:chExt cx="140760" cy="2876400"/>
            </a:xfrm>
          </p:grpSpPr>
          <p:sp>
            <p:nvSpPr>
              <p:cNvPr id="201" name=""/>
              <p:cNvSpPr/>
              <p:nvPr/>
            </p:nvSpPr>
            <p:spPr>
              <a:xfrm>
                <a:off x="4281840" y="304308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4281840" y="24951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281840" y="1954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4281840" y="14083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281840" y="8658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4281840" y="3193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39720"/>
                    <a:tab algn="l" pos="1279440"/>
                    <a:tab algn="l" pos="1919160"/>
                    <a:tab algn="l" pos="2558880"/>
                    <a:tab algn="l" pos="3198960"/>
                    <a:tab algn="l" pos="3838680"/>
                    <a:tab algn="l" pos="4478400"/>
                    <a:tab algn="l" pos="5118120"/>
                    <a:tab algn="l" pos="5757840"/>
                    <a:tab algn="l" pos="6397560"/>
                    <a:tab algn="l" pos="7037280"/>
                    <a:tab algn="l" pos="7677000"/>
                    <a:tab algn="l" pos="8317080"/>
                    <a:tab algn="l" pos="8956800"/>
                    <a:tab algn="l" pos="9596520"/>
                    <a:tab algn="l" pos="10236240"/>
                    <a:tab algn="l" pos="1087596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7" name=""/>
            <p:cNvGrpSpPr/>
            <p:nvPr/>
          </p:nvGrpSpPr>
          <p:grpSpPr>
            <a:xfrm>
              <a:off x="4525920" y="387360"/>
              <a:ext cx="31680" cy="2724840"/>
              <a:chOff x="4525920" y="387360"/>
              <a:chExt cx="31680" cy="2724840"/>
            </a:xfrm>
          </p:grpSpPr>
          <p:sp>
            <p:nvSpPr>
              <p:cNvPr id="208" name=""/>
              <p:cNvSpPr/>
              <p:nvPr/>
            </p:nvSpPr>
            <p:spPr>
              <a:xfrm flipH="1">
                <a:off x="4525920" y="3111840"/>
                <a:ext cx="3096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 flipH="1">
                <a:off x="4541040" y="2842560"/>
                <a:ext cx="154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flipH="1">
                <a:off x="4525920" y="2566800"/>
                <a:ext cx="309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 flipH="1">
                <a:off x="4541040" y="2291400"/>
                <a:ext cx="154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 flipH="1">
                <a:off x="4525920" y="2022120"/>
                <a:ext cx="3096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 flipH="1">
                <a:off x="4541040" y="1752480"/>
                <a:ext cx="154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 flipH="1">
                <a:off x="4525920" y="1477080"/>
                <a:ext cx="3096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 flipH="1">
                <a:off x="4541040" y="1201680"/>
                <a:ext cx="154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H="1">
                <a:off x="4525920" y="932040"/>
                <a:ext cx="309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 flipH="1">
                <a:off x="4541040" y="662760"/>
                <a:ext cx="154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H="1">
                <a:off x="4525920" y="387360"/>
                <a:ext cx="309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 flipV="1">
                <a:off x="4556880" y="387360"/>
                <a:ext cx="720" cy="2724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0" name=""/>
            <p:cNvGrpSpPr/>
            <p:nvPr/>
          </p:nvGrpSpPr>
          <p:grpSpPr>
            <a:xfrm>
              <a:off x="4566240" y="2193120"/>
              <a:ext cx="38880" cy="29160"/>
              <a:chOff x="4566240" y="2193120"/>
              <a:chExt cx="38880" cy="29160"/>
            </a:xfrm>
          </p:grpSpPr>
          <p:sp>
            <p:nvSpPr>
              <p:cNvPr id="221" name=""/>
              <p:cNvSpPr/>
              <p:nvPr/>
            </p:nvSpPr>
            <p:spPr>
              <a:xfrm>
                <a:off x="4566240" y="2193120"/>
                <a:ext cx="38880" cy="2916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4581720" y="220464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3" name=""/>
            <p:cNvGrpSpPr/>
            <p:nvPr/>
          </p:nvGrpSpPr>
          <p:grpSpPr>
            <a:xfrm>
              <a:off x="4842360" y="564120"/>
              <a:ext cx="38880" cy="30240"/>
              <a:chOff x="4842360" y="564120"/>
              <a:chExt cx="38880" cy="30240"/>
            </a:xfrm>
          </p:grpSpPr>
          <p:sp>
            <p:nvSpPr>
              <p:cNvPr id="224" name=""/>
              <p:cNvSpPr/>
              <p:nvPr/>
            </p:nvSpPr>
            <p:spPr>
              <a:xfrm>
                <a:off x="4842360" y="564120"/>
                <a:ext cx="3888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4857840" y="57600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6" name=""/>
            <p:cNvGrpSpPr/>
            <p:nvPr/>
          </p:nvGrpSpPr>
          <p:grpSpPr>
            <a:xfrm>
              <a:off x="4897440" y="2773800"/>
              <a:ext cx="38880" cy="30600"/>
              <a:chOff x="4897440" y="2773800"/>
              <a:chExt cx="38880" cy="30600"/>
            </a:xfrm>
          </p:grpSpPr>
          <p:sp>
            <p:nvSpPr>
              <p:cNvPr id="227" name=""/>
              <p:cNvSpPr/>
              <p:nvPr/>
            </p:nvSpPr>
            <p:spPr>
              <a:xfrm>
                <a:off x="4897440" y="277380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4912920" y="27860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9" name=""/>
            <p:cNvGrpSpPr/>
            <p:nvPr/>
          </p:nvGrpSpPr>
          <p:grpSpPr>
            <a:xfrm>
              <a:off x="4991400" y="2694240"/>
              <a:ext cx="38880" cy="32040"/>
              <a:chOff x="4991400" y="2694240"/>
              <a:chExt cx="38880" cy="32040"/>
            </a:xfrm>
          </p:grpSpPr>
          <p:sp>
            <p:nvSpPr>
              <p:cNvPr id="230" name=""/>
              <p:cNvSpPr/>
              <p:nvPr/>
            </p:nvSpPr>
            <p:spPr>
              <a:xfrm>
                <a:off x="4991400" y="2694240"/>
                <a:ext cx="388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5006880" y="27068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2" name=""/>
            <p:cNvGrpSpPr/>
            <p:nvPr/>
          </p:nvGrpSpPr>
          <p:grpSpPr>
            <a:xfrm>
              <a:off x="5030640" y="1702080"/>
              <a:ext cx="40680" cy="30600"/>
              <a:chOff x="5030640" y="1702080"/>
              <a:chExt cx="40680" cy="30600"/>
            </a:xfrm>
          </p:grpSpPr>
          <p:sp>
            <p:nvSpPr>
              <p:cNvPr id="233" name=""/>
              <p:cNvSpPr/>
              <p:nvPr/>
            </p:nvSpPr>
            <p:spPr>
              <a:xfrm>
                <a:off x="5030640" y="1702080"/>
                <a:ext cx="406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5046840" y="171432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5" name=""/>
            <p:cNvGrpSpPr/>
            <p:nvPr/>
          </p:nvGrpSpPr>
          <p:grpSpPr>
            <a:xfrm>
              <a:off x="5038560" y="1428120"/>
              <a:ext cx="40680" cy="30600"/>
              <a:chOff x="5038560" y="1428120"/>
              <a:chExt cx="40680" cy="30600"/>
            </a:xfrm>
          </p:grpSpPr>
          <p:sp>
            <p:nvSpPr>
              <p:cNvPr id="236" name=""/>
              <p:cNvSpPr/>
              <p:nvPr/>
            </p:nvSpPr>
            <p:spPr>
              <a:xfrm>
                <a:off x="5038560" y="1428120"/>
                <a:ext cx="406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5054760" y="144036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8" name=""/>
            <p:cNvGrpSpPr/>
            <p:nvPr/>
          </p:nvGrpSpPr>
          <p:grpSpPr>
            <a:xfrm>
              <a:off x="5071320" y="1629360"/>
              <a:ext cx="38520" cy="30600"/>
              <a:chOff x="5071320" y="1629360"/>
              <a:chExt cx="38520" cy="30600"/>
            </a:xfrm>
          </p:grpSpPr>
          <p:sp>
            <p:nvSpPr>
              <p:cNvPr id="239" name=""/>
              <p:cNvSpPr/>
              <p:nvPr/>
            </p:nvSpPr>
            <p:spPr>
              <a:xfrm>
                <a:off x="5071320" y="162936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5086440" y="164160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1" name=""/>
            <p:cNvGrpSpPr/>
            <p:nvPr/>
          </p:nvGrpSpPr>
          <p:grpSpPr>
            <a:xfrm>
              <a:off x="5101920" y="1470240"/>
              <a:ext cx="40680" cy="30240"/>
              <a:chOff x="5101920" y="1470240"/>
              <a:chExt cx="40680" cy="30240"/>
            </a:xfrm>
          </p:grpSpPr>
          <p:sp>
            <p:nvSpPr>
              <p:cNvPr id="242" name=""/>
              <p:cNvSpPr/>
              <p:nvPr/>
            </p:nvSpPr>
            <p:spPr>
              <a:xfrm>
                <a:off x="5101920" y="1470240"/>
                <a:ext cx="4068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5118120" y="14821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4" name=""/>
            <p:cNvGrpSpPr/>
            <p:nvPr/>
          </p:nvGrpSpPr>
          <p:grpSpPr>
            <a:xfrm>
              <a:off x="5173200" y="2738160"/>
              <a:ext cx="38880" cy="30600"/>
              <a:chOff x="5173200" y="2738160"/>
              <a:chExt cx="38880" cy="30600"/>
            </a:xfrm>
          </p:grpSpPr>
          <p:sp>
            <p:nvSpPr>
              <p:cNvPr id="245" name=""/>
              <p:cNvSpPr/>
              <p:nvPr/>
            </p:nvSpPr>
            <p:spPr>
              <a:xfrm>
                <a:off x="5173200" y="273816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5188680" y="275040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7" name=""/>
            <p:cNvGrpSpPr/>
            <p:nvPr/>
          </p:nvGrpSpPr>
          <p:grpSpPr>
            <a:xfrm>
              <a:off x="5204160" y="1256400"/>
              <a:ext cx="40320" cy="30240"/>
              <a:chOff x="5204160" y="1256400"/>
              <a:chExt cx="40320" cy="30240"/>
            </a:xfrm>
          </p:grpSpPr>
          <p:sp>
            <p:nvSpPr>
              <p:cNvPr id="248" name=""/>
              <p:cNvSpPr/>
              <p:nvPr/>
            </p:nvSpPr>
            <p:spPr>
              <a:xfrm>
                <a:off x="5204160" y="1256400"/>
                <a:ext cx="4032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5220000" y="126828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0" name=""/>
            <p:cNvGrpSpPr/>
            <p:nvPr/>
          </p:nvGrpSpPr>
          <p:grpSpPr>
            <a:xfrm>
              <a:off x="5261400" y="1979280"/>
              <a:ext cx="38520" cy="30600"/>
              <a:chOff x="5261400" y="1979280"/>
              <a:chExt cx="38520" cy="30600"/>
            </a:xfrm>
          </p:grpSpPr>
          <p:sp>
            <p:nvSpPr>
              <p:cNvPr id="251" name=""/>
              <p:cNvSpPr/>
              <p:nvPr/>
            </p:nvSpPr>
            <p:spPr>
              <a:xfrm>
                <a:off x="5261400" y="1979280"/>
                <a:ext cx="385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5276520" y="199152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3" name=""/>
            <p:cNvGrpSpPr/>
            <p:nvPr/>
          </p:nvGrpSpPr>
          <p:grpSpPr>
            <a:xfrm>
              <a:off x="5299920" y="1849680"/>
              <a:ext cx="38880" cy="30240"/>
              <a:chOff x="5299920" y="1849680"/>
              <a:chExt cx="38880" cy="30240"/>
            </a:xfrm>
          </p:grpSpPr>
          <p:sp>
            <p:nvSpPr>
              <p:cNvPr id="254" name=""/>
              <p:cNvSpPr/>
              <p:nvPr/>
            </p:nvSpPr>
            <p:spPr>
              <a:xfrm>
                <a:off x="5299920" y="1849680"/>
                <a:ext cx="3888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5315400" y="18615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6" name=""/>
            <p:cNvGrpSpPr/>
            <p:nvPr/>
          </p:nvGrpSpPr>
          <p:grpSpPr>
            <a:xfrm>
              <a:off x="5339160" y="1606320"/>
              <a:ext cx="38880" cy="28800"/>
              <a:chOff x="5339160" y="1606320"/>
              <a:chExt cx="38880" cy="28800"/>
            </a:xfrm>
          </p:grpSpPr>
          <p:sp>
            <p:nvSpPr>
              <p:cNvPr id="257" name=""/>
              <p:cNvSpPr/>
              <p:nvPr/>
            </p:nvSpPr>
            <p:spPr>
              <a:xfrm>
                <a:off x="5339160" y="1606320"/>
                <a:ext cx="38880" cy="288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5354640" y="16178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9" name=""/>
            <p:cNvGrpSpPr/>
            <p:nvPr/>
          </p:nvGrpSpPr>
          <p:grpSpPr>
            <a:xfrm>
              <a:off x="5418360" y="1937160"/>
              <a:ext cx="38880" cy="28800"/>
              <a:chOff x="5418360" y="1937160"/>
              <a:chExt cx="38880" cy="28800"/>
            </a:xfrm>
          </p:grpSpPr>
          <p:sp>
            <p:nvSpPr>
              <p:cNvPr id="260" name=""/>
              <p:cNvSpPr/>
              <p:nvPr/>
            </p:nvSpPr>
            <p:spPr>
              <a:xfrm>
                <a:off x="5418360" y="1937160"/>
                <a:ext cx="38880" cy="288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5433840" y="19486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2" name=""/>
            <p:cNvGrpSpPr/>
            <p:nvPr/>
          </p:nvGrpSpPr>
          <p:grpSpPr>
            <a:xfrm>
              <a:off x="5441400" y="1708560"/>
              <a:ext cx="40320" cy="30600"/>
              <a:chOff x="5441400" y="1708560"/>
              <a:chExt cx="40320" cy="30600"/>
            </a:xfrm>
          </p:grpSpPr>
          <p:sp>
            <p:nvSpPr>
              <p:cNvPr id="263" name=""/>
              <p:cNvSpPr/>
              <p:nvPr/>
            </p:nvSpPr>
            <p:spPr>
              <a:xfrm>
                <a:off x="5441400" y="170856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5457600" y="172080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5" name=""/>
            <p:cNvGrpSpPr/>
            <p:nvPr/>
          </p:nvGrpSpPr>
          <p:grpSpPr>
            <a:xfrm>
              <a:off x="5545080" y="1292040"/>
              <a:ext cx="38880" cy="32040"/>
              <a:chOff x="5545080" y="1292040"/>
              <a:chExt cx="38880" cy="32040"/>
            </a:xfrm>
          </p:grpSpPr>
          <p:sp>
            <p:nvSpPr>
              <p:cNvPr id="266" name=""/>
              <p:cNvSpPr/>
              <p:nvPr/>
            </p:nvSpPr>
            <p:spPr>
              <a:xfrm>
                <a:off x="5545080" y="1292040"/>
                <a:ext cx="388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5560560" y="13046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8" name=""/>
            <p:cNvGrpSpPr/>
            <p:nvPr/>
          </p:nvGrpSpPr>
          <p:grpSpPr>
            <a:xfrm>
              <a:off x="5608440" y="2327760"/>
              <a:ext cx="38880" cy="30600"/>
              <a:chOff x="5608440" y="2327760"/>
              <a:chExt cx="38880" cy="30600"/>
            </a:xfrm>
          </p:grpSpPr>
          <p:sp>
            <p:nvSpPr>
              <p:cNvPr id="269" name=""/>
              <p:cNvSpPr/>
              <p:nvPr/>
            </p:nvSpPr>
            <p:spPr>
              <a:xfrm>
                <a:off x="5608440" y="232776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5623920" y="2340000"/>
                <a:ext cx="108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1" name=""/>
            <p:cNvGrpSpPr/>
            <p:nvPr/>
          </p:nvGrpSpPr>
          <p:grpSpPr>
            <a:xfrm>
              <a:off x="5614920" y="1324440"/>
              <a:ext cx="40320" cy="30600"/>
              <a:chOff x="5614920" y="1324440"/>
              <a:chExt cx="40320" cy="30600"/>
            </a:xfrm>
          </p:grpSpPr>
          <p:sp>
            <p:nvSpPr>
              <p:cNvPr id="272" name=""/>
              <p:cNvSpPr/>
              <p:nvPr/>
            </p:nvSpPr>
            <p:spPr>
              <a:xfrm>
                <a:off x="5614920" y="132444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5631120" y="13366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4" name=""/>
            <p:cNvGrpSpPr/>
            <p:nvPr/>
          </p:nvGrpSpPr>
          <p:grpSpPr>
            <a:xfrm>
              <a:off x="5647320" y="1733040"/>
              <a:ext cx="38880" cy="32040"/>
              <a:chOff x="5647320" y="1733040"/>
              <a:chExt cx="38880" cy="32040"/>
            </a:xfrm>
          </p:grpSpPr>
          <p:sp>
            <p:nvSpPr>
              <p:cNvPr id="275" name=""/>
              <p:cNvSpPr/>
              <p:nvPr/>
            </p:nvSpPr>
            <p:spPr>
              <a:xfrm>
                <a:off x="5647320" y="1733040"/>
                <a:ext cx="388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5662800" y="17456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7" name=""/>
            <p:cNvGrpSpPr/>
            <p:nvPr/>
          </p:nvGrpSpPr>
          <p:grpSpPr>
            <a:xfrm>
              <a:off x="5733720" y="1942200"/>
              <a:ext cx="40320" cy="30600"/>
              <a:chOff x="5733720" y="1942200"/>
              <a:chExt cx="40320" cy="30600"/>
            </a:xfrm>
          </p:grpSpPr>
          <p:sp>
            <p:nvSpPr>
              <p:cNvPr id="278" name=""/>
              <p:cNvSpPr/>
              <p:nvPr/>
            </p:nvSpPr>
            <p:spPr>
              <a:xfrm>
                <a:off x="5733720" y="194220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5749920" y="195444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0" name=""/>
            <p:cNvGrpSpPr/>
            <p:nvPr/>
          </p:nvGrpSpPr>
          <p:grpSpPr>
            <a:xfrm>
              <a:off x="5733720" y="1218960"/>
              <a:ext cx="40320" cy="30600"/>
              <a:chOff x="5733720" y="1218960"/>
              <a:chExt cx="40320" cy="30600"/>
            </a:xfrm>
          </p:grpSpPr>
          <p:sp>
            <p:nvSpPr>
              <p:cNvPr id="281" name=""/>
              <p:cNvSpPr/>
              <p:nvPr/>
            </p:nvSpPr>
            <p:spPr>
              <a:xfrm>
                <a:off x="5733720" y="121896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5749920" y="123120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3" name=""/>
            <p:cNvGrpSpPr/>
            <p:nvPr/>
          </p:nvGrpSpPr>
          <p:grpSpPr>
            <a:xfrm>
              <a:off x="5774040" y="2138040"/>
              <a:ext cx="38880" cy="30600"/>
              <a:chOff x="5774040" y="2138040"/>
              <a:chExt cx="38880" cy="30600"/>
            </a:xfrm>
          </p:grpSpPr>
          <p:sp>
            <p:nvSpPr>
              <p:cNvPr id="284" name=""/>
              <p:cNvSpPr/>
              <p:nvPr/>
            </p:nvSpPr>
            <p:spPr>
              <a:xfrm>
                <a:off x="5774040" y="213804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5789520" y="215028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6" name=""/>
            <p:cNvGrpSpPr/>
            <p:nvPr/>
          </p:nvGrpSpPr>
          <p:grpSpPr>
            <a:xfrm>
              <a:off x="5797080" y="1230480"/>
              <a:ext cx="40320" cy="30600"/>
              <a:chOff x="5797080" y="1230480"/>
              <a:chExt cx="40320" cy="30600"/>
            </a:xfrm>
          </p:grpSpPr>
          <p:sp>
            <p:nvSpPr>
              <p:cNvPr id="287" name=""/>
              <p:cNvSpPr/>
              <p:nvPr/>
            </p:nvSpPr>
            <p:spPr>
              <a:xfrm>
                <a:off x="5797080" y="1230480"/>
                <a:ext cx="4032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5813280" y="12427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9" name=""/>
            <p:cNvGrpSpPr/>
            <p:nvPr/>
          </p:nvGrpSpPr>
          <p:grpSpPr>
            <a:xfrm>
              <a:off x="6389280" y="1856160"/>
              <a:ext cx="38880" cy="30600"/>
              <a:chOff x="6389280" y="1856160"/>
              <a:chExt cx="38880" cy="30600"/>
            </a:xfrm>
          </p:grpSpPr>
          <p:sp>
            <p:nvSpPr>
              <p:cNvPr id="290" name=""/>
              <p:cNvSpPr/>
              <p:nvPr/>
            </p:nvSpPr>
            <p:spPr>
              <a:xfrm>
                <a:off x="6389280" y="1856160"/>
                <a:ext cx="38880" cy="3060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6404760" y="1868400"/>
                <a:ext cx="720" cy="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2" name=""/>
            <p:cNvGrpSpPr/>
            <p:nvPr/>
          </p:nvGrpSpPr>
          <p:grpSpPr>
            <a:xfrm>
              <a:off x="6618240" y="1849680"/>
              <a:ext cx="38880" cy="30240"/>
              <a:chOff x="6618240" y="1849680"/>
              <a:chExt cx="38880" cy="30240"/>
            </a:xfrm>
          </p:grpSpPr>
          <p:sp>
            <p:nvSpPr>
              <p:cNvPr id="293" name=""/>
              <p:cNvSpPr/>
              <p:nvPr/>
            </p:nvSpPr>
            <p:spPr>
              <a:xfrm>
                <a:off x="6618240" y="1849680"/>
                <a:ext cx="38880" cy="302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6633720" y="18615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5" name=""/>
            <p:cNvGrpSpPr/>
            <p:nvPr/>
          </p:nvGrpSpPr>
          <p:grpSpPr>
            <a:xfrm>
              <a:off x="4558320" y="1611360"/>
              <a:ext cx="2730240" cy="264240"/>
              <a:chOff x="4558320" y="1611360"/>
              <a:chExt cx="2730240" cy="264240"/>
            </a:xfrm>
          </p:grpSpPr>
          <p:sp>
            <p:nvSpPr>
              <p:cNvPr id="296" name=""/>
              <p:cNvSpPr/>
              <p:nvPr/>
            </p:nvSpPr>
            <p:spPr>
              <a:xfrm>
                <a:off x="4558320" y="1611360"/>
                <a:ext cx="2730240" cy="264240"/>
              </a:xfrm>
              <a:custGeom>
                <a:avLst/>
                <a:gdLst/>
                <a:ahLst/>
                <a:rect l="l" t="t" r="r" b="b"/>
                <a:pathLst>
                  <a:path w="2768" h="344">
                    <a:moveTo>
                      <a:pt x="0" y="344"/>
                    </a:moveTo>
                    <a:lnTo>
                      <a:pt x="2768" y="0"/>
                    </a:lnTo>
                    <a:lnTo>
                      <a:pt x="2768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 flipV="1">
                <a:off x="4558320" y="1611360"/>
                <a:ext cx="2730240" cy="264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8" name=""/>
            <p:cNvSpPr/>
            <p:nvPr/>
          </p:nvSpPr>
          <p:spPr>
            <a:xfrm>
              <a:off x="4746600" y="291600"/>
              <a:ext cx="21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39720"/>
                  <a:tab algn="l" pos="1279440"/>
                  <a:tab algn="l" pos="1919160"/>
                  <a:tab algn="l" pos="2558880"/>
                  <a:tab algn="l" pos="3198960"/>
                  <a:tab algn="l" pos="3838680"/>
                  <a:tab algn="l" pos="4478400"/>
                  <a:tab algn="l" pos="5118120"/>
                  <a:tab algn="l" pos="5757840"/>
                  <a:tab algn="l" pos="6397560"/>
                  <a:tab algn="l" pos="7037280"/>
                  <a:tab algn="l" pos="7677000"/>
                  <a:tab algn="l" pos="8317080"/>
                  <a:tab algn="l" pos="8956800"/>
                  <a:tab algn="l" pos="9596520"/>
                  <a:tab algn="l" pos="10236240"/>
                  <a:tab algn="l" pos="1087596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y = 31.479 + 6.0960e-4x   R^2 = 0.00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 rot="16200000">
              <a:off x="3285360" y="1596600"/>
              <a:ext cx="1474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639720"/>
                  <a:tab algn="l" pos="1279440"/>
                  <a:tab algn="l" pos="1919160"/>
                  <a:tab algn="l" pos="2558880"/>
                  <a:tab algn="l" pos="3198960"/>
                  <a:tab algn="l" pos="3838680"/>
                  <a:tab algn="l" pos="4478400"/>
                  <a:tab algn="l" pos="5118120"/>
                  <a:tab algn="l" pos="5757840"/>
                  <a:tab algn="l" pos="6397560"/>
                  <a:tab algn="l" pos="7037280"/>
                  <a:tab algn="l" pos="7677000"/>
                  <a:tab algn="l" pos="8317080"/>
                  <a:tab algn="l" pos="8956800"/>
                  <a:tab algn="l" pos="9596520"/>
                  <a:tab algn="l" pos="10236240"/>
                  <a:tab algn="l" pos="1087596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otal fat oxidation (g/6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28T19:27:52Z</dcterms:created>
  <dc:creator>janine</dc:creator>
  <dc:description/>
  <dc:language>en-US</dc:language>
  <cp:lastModifiedBy>higbee</cp:lastModifiedBy>
  <dcterms:modified xsi:type="dcterms:W3CDTF">2004-10-02T00:16:34Z</dcterms:modified>
  <cp:revision>3</cp:revision>
  <dc:subject/>
  <dc:title>Slide 1</dc:title>
</cp:coreProperties>
</file>